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E19DE-608C-4BC2-9B7C-F29A5AC3AB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C410F-3ACE-421C-A737-9CC9D4498D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667CBB-C9D6-476B-AC23-7522C0FAB5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04D3F-44C1-4030-83AF-F098F6C78D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FBF5E-F4AE-4FDC-B802-CD2F53CBC8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F290E-0481-4134-9150-1B9314C2E6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9CEC3-CB80-4BB8-81D6-030CAA2AAC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E3621-A096-4FAA-A9E8-DE58056B9E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15518-2560-4D52-82DC-8263726674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EC557-0891-4D92-9D8C-A8C98DE366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457FF-BE0D-4126-ABF5-5DBC08B75B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269E3-8974-4095-B226-E5E74AD5A4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7B01E3-43A2-4EDF-A743-CE40E722A89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ifferential CaMKII.1 splicing depends on sequence differences in the CaMKII.1 locus and correlates with endogenous circadian period length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971800" y="1817640"/>
            <a:ext cx="3200400" cy="32529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T S Kaiser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5 (2016) doi:10.1038/nature2015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16T11:18:59Z</dcterms:created>
  <dc:creator>ravikumar.n</dc:creator>
  <dc:description/>
  <dc:language>en-US</dc:language>
  <cp:lastModifiedBy>ravikumar.n</cp:lastModifiedBy>
  <dcterms:modified xsi:type="dcterms:W3CDTF">2016-11-16T11:19:02Z</dcterms:modified>
  <cp:revision>1</cp:revision>
  <dc:subject/>
  <dc:title>Differential CaMKII.1 splicing depends on sequence differences in the CaMKII.1 locus and correlates with endogenous circadian period lengths</dc:title>
</cp:coreProperties>
</file>